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73" r:id="rId2"/>
  </p:sldIdLst>
  <p:sldSz cx="6858000" cy="9144000" type="letter"/>
  <p:notesSz cx="7102475" cy="93884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6DFF00"/>
    <a:srgbClr val="FFFF00"/>
    <a:srgbClr val="171717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15" autoAdjust="0"/>
    <p:restoredTop sz="71973" autoAdjust="0"/>
  </p:normalViewPr>
  <p:slideViewPr>
    <p:cSldViewPr snapToGrid="0">
      <p:cViewPr varScale="1">
        <p:scale>
          <a:sx n="67" d="100"/>
          <a:sy n="67" d="100"/>
        </p:scale>
        <p:origin x="4112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1" tIns="47111" rIns="94221" bIns="4711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3" y="0"/>
            <a:ext cx="3077739" cy="471054"/>
          </a:xfrm>
          <a:prstGeom prst="rect">
            <a:avLst/>
          </a:prstGeom>
        </p:spPr>
        <p:txBody>
          <a:bodyPr vert="horz" lIns="94221" tIns="47111" rIns="94221" bIns="47111" rtlCol="0"/>
          <a:lstStyle>
            <a:lvl1pPr algn="r">
              <a:defRPr sz="1200"/>
            </a:lvl1pPr>
          </a:lstStyle>
          <a:p>
            <a:fld id="{E92D1EB7-785E-4EC2-902A-935C806FE68F}" type="datetimeFigureOut">
              <a:rPr lang="en-US" smtClean="0"/>
              <a:t>4/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73163"/>
            <a:ext cx="2378075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1" tIns="47111" rIns="94221" bIns="4711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3"/>
            <a:ext cx="5681980" cy="3696713"/>
          </a:xfrm>
          <a:prstGeom prst="rect">
            <a:avLst/>
          </a:prstGeom>
        </p:spPr>
        <p:txBody>
          <a:bodyPr vert="horz" lIns="94221" tIns="47111" rIns="94221" bIns="4711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3"/>
            <a:ext cx="3077739" cy="471053"/>
          </a:xfrm>
          <a:prstGeom prst="rect">
            <a:avLst/>
          </a:prstGeom>
        </p:spPr>
        <p:txBody>
          <a:bodyPr vert="horz" lIns="94221" tIns="47111" rIns="94221" bIns="4711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3" y="8917423"/>
            <a:ext cx="3077739" cy="471053"/>
          </a:xfrm>
          <a:prstGeom prst="rect">
            <a:avLst/>
          </a:prstGeom>
        </p:spPr>
        <p:txBody>
          <a:bodyPr vert="horz" lIns="94221" tIns="47111" rIns="94221" bIns="47111" rtlCol="0" anchor="b"/>
          <a:lstStyle>
            <a:lvl1pPr algn="r">
              <a:defRPr sz="1200"/>
            </a:lvl1pPr>
          </a:lstStyle>
          <a:p>
            <a:fld id="{122F76DF-B0D4-4C7B-A882-555C14374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139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0" dirty="0">
                <a:solidFill>
                  <a:srgbClr val="734126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presentative TEM of MERCS (blue arrows) in the hippocampus of NTG (a–d), APP/PS1 (e–h) and APP/PS1 + CP2 (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–l) mice. MOAS mitochondria are shown in (g) and (h). Scale bar, 0.5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dirty="0">
                <a:effectLst/>
              </a:rPr>
              <a:t> </a:t>
            </a:r>
            <a:endParaRPr lang="en-US" sz="1200" b="1" i="0" dirty="0">
              <a:solidFill>
                <a:srgbClr val="734126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i="0" dirty="0">
              <a:solidFill>
                <a:srgbClr val="734126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2F76DF-B0D4-4C7B-A882-555C143747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8295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615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4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363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654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04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440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427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038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563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008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536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663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different, several&#10;&#10;Description automatically generated">
            <a:extLst>
              <a:ext uri="{FF2B5EF4-FFF2-40B4-BE49-F238E27FC236}">
                <a16:creationId xmlns:a16="http://schemas.microsoft.com/office/drawing/2014/main" id="{D014D577-FA0E-484B-6216-43B2EAFFD7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500" y="142461"/>
            <a:ext cx="6166999" cy="824947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69AE433-75C8-1B35-03BF-D07A7AF3CBB8}"/>
              </a:ext>
            </a:extLst>
          </p:cNvPr>
          <p:cNvSpPr txBox="1"/>
          <p:nvPr/>
        </p:nvSpPr>
        <p:spPr>
          <a:xfrm>
            <a:off x="345500" y="8313003"/>
            <a:ext cx="61669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0" dirty="0">
                <a:solidFill>
                  <a:srgbClr val="734126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presentative TEM of MERCS (blue arrows) in the hippocampus of NTG (a–d), APP/PS1 (e–h) and APP/PS1 + CP2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–l) mice. MOAS mitochondria are shown in (g) and (h). Scale bar, 0.5 </a:t>
            </a:r>
            <a:r>
              <a:rPr lang="en-US" sz="12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200" dirty="0">
                <a:effectLst/>
              </a:rPr>
              <a:t> </a:t>
            </a:r>
            <a:endParaRPr lang="en-US" sz="1200" b="1" i="0" dirty="0">
              <a:solidFill>
                <a:srgbClr val="734126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i="0" dirty="0">
              <a:solidFill>
                <a:srgbClr val="734126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3064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553</TotalTime>
  <Words>121</Words>
  <Application>Microsoft Macintosh PowerPoint</Application>
  <PresentationFormat>Letter Paper (8.5x11 in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es, Jessica D.</dc:creator>
  <cp:lastModifiedBy>Trushina, Eugenia, Ph.D.</cp:lastModifiedBy>
  <cp:revision>698</cp:revision>
  <cp:lastPrinted>2022-06-28T14:24:17Z</cp:lastPrinted>
  <dcterms:created xsi:type="dcterms:W3CDTF">2022-03-01T14:24:29Z</dcterms:created>
  <dcterms:modified xsi:type="dcterms:W3CDTF">2023-04-07T16:18:15Z</dcterms:modified>
</cp:coreProperties>
</file>